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9" d="100"/>
          <a:sy n="139" d="100"/>
        </p:scale>
        <p:origin x="-3152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093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912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637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18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652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046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941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072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361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377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152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B19E4-5174-564F-B7A1-62B8B2325720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CFDD2-A295-8043-87F0-6EDBCD9E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196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5509" y="1364753"/>
            <a:ext cx="3479800" cy="29845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49289" y="345232"/>
            <a:ext cx="2655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1 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703503" y="4934059"/>
            <a:ext cx="60117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Suppl</a:t>
            </a:r>
            <a:r>
              <a:rPr lang="en-US" sz="1200" dirty="0"/>
              <a:t> </a:t>
            </a:r>
            <a:r>
              <a:rPr lang="en-US" sz="1200" dirty="0" smtClean="0"/>
              <a:t>Fig 1:  Expression of SNCG mRNA in benign fallopian tube epithelium and ovarian cancer tissues.  </a:t>
            </a:r>
            <a:r>
              <a:rPr lang="en-US" sz="1200" dirty="0" smtClean="0"/>
              <a:t>RNA from </a:t>
            </a:r>
            <a:r>
              <a:rPr lang="en-US" sz="1200" dirty="0" smtClean="0"/>
              <a:t>human  benign fallopian tube epithelium and ovarian cancer tissues was subjected to RT-real time PCR for SNCG. SNCG as a ratio of the housekeeping gene TBP is </a:t>
            </a:r>
            <a:r>
              <a:rPr lang="en-US" sz="1200" dirty="0" smtClean="0"/>
              <a:t>presented using delta delta CT calculations.    </a:t>
            </a:r>
            <a:r>
              <a:rPr lang="en-US" sz="1200" dirty="0" smtClean="0"/>
              <a:t>*= p&lt;0.05.  </a:t>
            </a:r>
          </a:p>
          <a:p>
            <a:r>
              <a:rPr lang="en-US" sz="1200" dirty="0" smtClean="0"/>
              <a:t>FT – fallopian tube; </a:t>
            </a:r>
            <a:r>
              <a:rPr lang="en-US" sz="1200" dirty="0" err="1" smtClean="0"/>
              <a:t>OvCa</a:t>
            </a:r>
            <a:r>
              <a:rPr lang="en-US" sz="1200" dirty="0" smtClean="0"/>
              <a:t> – </a:t>
            </a:r>
            <a:r>
              <a:rPr lang="en-US" sz="1200" dirty="0"/>
              <a:t>o</a:t>
            </a:r>
            <a:r>
              <a:rPr lang="en-US" sz="1200" dirty="0" smtClean="0"/>
              <a:t>varian cancer</a:t>
            </a:r>
            <a:endParaRPr lang="en-US" sz="1200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2804871" y="1955349"/>
            <a:ext cx="1361321" cy="91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316507" y="1651901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6461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6</TotalTime>
  <Words>76</Words>
  <Application>Microsoft Macintosh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Kim</dc:creator>
  <cp:lastModifiedBy>J Julie Kim</cp:lastModifiedBy>
  <cp:revision>15</cp:revision>
  <dcterms:created xsi:type="dcterms:W3CDTF">2016-02-19T15:48:04Z</dcterms:created>
  <dcterms:modified xsi:type="dcterms:W3CDTF">2016-10-13T15:59:15Z</dcterms:modified>
</cp:coreProperties>
</file>